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2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620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4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686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474" autoAdjust="0"/>
  </p:normalViewPr>
  <p:slideViewPr>
    <p:cSldViewPr snapToGrid="0">
      <p:cViewPr varScale="1">
        <p:scale>
          <a:sx n="51" d="100"/>
          <a:sy n="51" d="100"/>
        </p:scale>
        <p:origin x="2136" y="8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7DC28-9DC6-6E48-8536-3695BBCB729C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BFEA71-BC19-2344-B1DE-8DA16567FAF2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550664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501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8E8D99-2080-444B-A941-58AB31AC8F53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468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5010" y="868468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518817-FCAB-0648-BF8E-59AEA9D0B004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48453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518817-FCAB-0648-BF8E-59AEA9D0B004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002BE-3B85-6B41-9761-2010FD3EEF9F}" type="datetimeFigureOut">
              <a:rPr lang="ja-JP" altLang="en-US" smtClean="0"/>
              <a:pPr/>
              <a:t>2021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5072E-BE8C-CE41-A9D4-4AD24103965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25">
            <a:extLst>
              <a:ext uri="{FF2B5EF4-FFF2-40B4-BE49-F238E27FC236}">
                <a16:creationId xmlns:a16="http://schemas.microsoft.com/office/drawing/2014/main" id="{1DDDF529-3D6E-D542-A43F-54743EE4D386}"/>
              </a:ext>
            </a:extLst>
          </p:cNvPr>
          <p:cNvSpPr txBox="1"/>
          <p:nvPr/>
        </p:nvSpPr>
        <p:spPr>
          <a:xfrm>
            <a:off x="0" y="8774668"/>
            <a:ext cx="3124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Vi et al. S2 Fig</a:t>
            </a:r>
          </a:p>
        </p:txBody>
      </p:sp>
      <p:grpSp>
        <p:nvGrpSpPr>
          <p:cNvPr id="71" name="Group 70"/>
          <p:cNvGrpSpPr/>
          <p:nvPr/>
        </p:nvGrpSpPr>
        <p:grpSpPr>
          <a:xfrm>
            <a:off x="0" y="3434411"/>
            <a:ext cx="3497580" cy="2172685"/>
            <a:chOff x="76200" y="3271804"/>
            <a:chExt cx="3497580" cy="2172685"/>
          </a:xfrm>
        </p:grpSpPr>
        <p:grpSp>
          <p:nvGrpSpPr>
            <p:cNvPr id="67" name="Group 66"/>
            <p:cNvGrpSpPr/>
            <p:nvPr/>
          </p:nvGrpSpPr>
          <p:grpSpPr>
            <a:xfrm>
              <a:off x="76200" y="3271804"/>
              <a:ext cx="3497580" cy="2172685"/>
              <a:chOff x="76200" y="3271804"/>
              <a:chExt cx="3497580" cy="2172685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76200" y="3271804"/>
                <a:ext cx="3497580" cy="2172685"/>
                <a:chOff x="1395072" y="6127605"/>
                <a:chExt cx="4500885" cy="2502281"/>
              </a:xfrm>
            </p:grpSpPr>
            <p:pic>
              <p:nvPicPr>
                <p:cNvPr id="8" name="Picture 7"/>
                <p:cNvPicPr/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95072" y="6594618"/>
                  <a:ext cx="1985010" cy="1987813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9" name="Picture 8"/>
                <p:cNvPicPr/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95631" y="6468578"/>
                  <a:ext cx="2600326" cy="2161308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10" name="Rectangle 9"/>
                <p:cNvSpPr/>
                <p:nvPr/>
              </p:nvSpPr>
              <p:spPr>
                <a:xfrm>
                  <a:off x="1755903" y="6127605"/>
                  <a:ext cx="3131798" cy="31902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1200" b="1" dirty="0">
                      <a:latin typeface="Arial" panose="020B0604020202020204" pitchFamily="34" charset="0"/>
                      <a:ea typeface="游明朝" panose="02020400000000000000" pitchFamily="18" charset="-128"/>
                    </a:rPr>
                    <a:t>strains containing </a:t>
                  </a:r>
                  <a:r>
                    <a:rPr lang="en-US" sz="1200" b="1" i="1" dirty="0"/>
                    <a:t>MSY1</a:t>
                  </a:r>
                  <a:r>
                    <a:rPr lang="en-US" sz="1200" b="1" dirty="0"/>
                    <a:t>pro-</a:t>
                  </a:r>
                  <a:r>
                    <a:rPr lang="en-US" sz="1200" b="1" i="1" dirty="0"/>
                    <a:t>GFP</a:t>
                  </a:r>
                  <a:endParaRPr lang="en-US" sz="1200" dirty="0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1592644" y="6416275"/>
                  <a:ext cx="1846335" cy="2835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 </a:t>
                  </a:r>
                  <a:r>
                    <a:rPr lang="en-US" sz="1000" i="1" dirty="0"/>
                    <a:t>MSY1 </a:t>
                  </a:r>
                  <a:r>
                    <a:rPr lang="en-US" sz="1000" dirty="0"/>
                    <a:t>expression</a:t>
                  </a: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3916680" y="6416041"/>
                  <a:ext cx="1436370" cy="2835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i="1" dirty="0"/>
                    <a:t>GFP </a:t>
                  </a:r>
                  <a:r>
                    <a:rPr lang="en-US" sz="1000" dirty="0"/>
                    <a:t>expression</a:t>
                  </a:r>
                </a:p>
              </p:txBody>
            </p:sp>
          </p:grpSp>
          <p:grpSp>
            <p:nvGrpSpPr>
              <p:cNvPr id="35" name="Group 34"/>
              <p:cNvGrpSpPr/>
              <p:nvPr/>
            </p:nvGrpSpPr>
            <p:grpSpPr>
              <a:xfrm>
                <a:off x="460939" y="4421470"/>
                <a:ext cx="415127" cy="352295"/>
                <a:chOff x="979170" y="2550031"/>
                <a:chExt cx="710725" cy="589409"/>
              </a:xfrm>
            </p:grpSpPr>
            <p:sp>
              <p:nvSpPr>
                <p:cNvPr id="36" name="フリーフォーム 19">
                  <a:extLst>
                    <a:ext uri="{FF2B5EF4-FFF2-40B4-BE49-F238E27FC236}">
                      <a16:creationId xmlns:a16="http://schemas.microsoft.com/office/drawing/2014/main" id="{75EE5E4C-92A7-7E45-ABEE-843411717F4C}"/>
                    </a:ext>
                  </a:extLst>
                </p:cNvPr>
                <p:cNvSpPr/>
                <p:nvPr/>
              </p:nvSpPr>
              <p:spPr>
                <a:xfrm>
                  <a:off x="979170" y="2904776"/>
                  <a:ext cx="461010" cy="234664"/>
                </a:xfrm>
                <a:custGeom>
                  <a:avLst/>
                  <a:gdLst>
                    <a:gd name="connsiteX0" fmla="*/ 0 w 641384"/>
                    <a:gd name="connsiteY0" fmla="*/ 346388 h 346388"/>
                    <a:gd name="connsiteX1" fmla="*/ 0 w 641384"/>
                    <a:gd name="connsiteY1" fmla="*/ 0 h 346388"/>
                    <a:gd name="connsiteX2" fmla="*/ 641384 w 641384"/>
                    <a:gd name="connsiteY2" fmla="*/ 0 h 346388"/>
                    <a:gd name="connsiteX3" fmla="*/ 641384 w 641384"/>
                    <a:gd name="connsiteY3" fmla="*/ 346388 h 3463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41384" h="346388">
                      <a:moveTo>
                        <a:pt x="0" y="346388"/>
                      </a:moveTo>
                      <a:lnTo>
                        <a:pt x="0" y="0"/>
                      </a:lnTo>
                      <a:lnTo>
                        <a:pt x="641384" y="0"/>
                      </a:lnTo>
                      <a:lnTo>
                        <a:pt x="641384" y="346388"/>
                      </a:lnTo>
                    </a:path>
                  </a:pathLst>
                </a:cu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984070" y="2550031"/>
                  <a:ext cx="705825" cy="3861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ns</a:t>
                  </a:r>
                </a:p>
              </p:txBody>
            </p:sp>
          </p:grpSp>
        </p:grpSp>
        <p:grpSp>
          <p:nvGrpSpPr>
            <p:cNvPr id="38" name="Group 37"/>
            <p:cNvGrpSpPr/>
            <p:nvPr/>
          </p:nvGrpSpPr>
          <p:grpSpPr>
            <a:xfrm>
              <a:off x="1919490" y="4202687"/>
              <a:ext cx="415127" cy="352295"/>
              <a:chOff x="979170" y="2550031"/>
              <a:chExt cx="710725" cy="589409"/>
            </a:xfrm>
          </p:grpSpPr>
          <p:sp>
            <p:nvSpPr>
              <p:cNvPr id="39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2" name="Group 71"/>
          <p:cNvGrpSpPr/>
          <p:nvPr/>
        </p:nvGrpSpPr>
        <p:grpSpPr>
          <a:xfrm>
            <a:off x="100965" y="802754"/>
            <a:ext cx="3583306" cy="2310017"/>
            <a:chOff x="100965" y="802754"/>
            <a:chExt cx="3583306" cy="2310017"/>
          </a:xfrm>
        </p:grpSpPr>
        <p:grpSp>
          <p:nvGrpSpPr>
            <p:cNvPr id="65" name="Group 64"/>
            <p:cNvGrpSpPr/>
            <p:nvPr/>
          </p:nvGrpSpPr>
          <p:grpSpPr>
            <a:xfrm>
              <a:off x="100965" y="802754"/>
              <a:ext cx="3583306" cy="2310017"/>
              <a:chOff x="100965" y="802754"/>
              <a:chExt cx="3583306" cy="2310017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100965" y="802754"/>
                <a:ext cx="3583306" cy="2310017"/>
                <a:chOff x="1095374" y="737473"/>
                <a:chExt cx="4509308" cy="2512457"/>
              </a:xfrm>
            </p:grpSpPr>
            <p:pic>
              <p:nvPicPr>
                <p:cNvPr id="2" name="Picture 1"/>
                <p:cNvPicPr/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95374" y="1252545"/>
                  <a:ext cx="2192655" cy="195547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3" name="Picture 2"/>
                <p:cNvPicPr/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015605" y="1143000"/>
                  <a:ext cx="2589077" cy="210693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4" name="Rectangle 3"/>
                <p:cNvSpPr/>
                <p:nvPr/>
              </p:nvSpPr>
              <p:spPr>
                <a:xfrm>
                  <a:off x="1476129" y="737473"/>
                  <a:ext cx="3169185" cy="30127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1200" b="1" dirty="0">
                      <a:latin typeface="Arial" panose="020B0604020202020204" pitchFamily="34" charset="0"/>
                      <a:ea typeface="游明朝" panose="02020400000000000000" pitchFamily="18" charset="-128"/>
                    </a:rPr>
                    <a:t>strains containing </a:t>
                  </a:r>
                  <a:r>
                    <a:rPr lang="en-US" sz="1200" b="1" i="1" dirty="0"/>
                    <a:t>MRPL3</a:t>
                  </a:r>
                  <a:r>
                    <a:rPr lang="en-US" sz="1200" b="1" dirty="0"/>
                    <a:t>pro-</a:t>
                  </a:r>
                  <a:r>
                    <a:rPr lang="en-US" sz="1200" b="1" i="1" dirty="0"/>
                    <a:t>GFP</a:t>
                  </a:r>
                  <a:endParaRPr lang="en-US" sz="1200" dirty="0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1331531" y="1026836"/>
                  <a:ext cx="1822902" cy="2677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 </a:t>
                  </a:r>
                  <a:r>
                    <a:rPr lang="en-US" sz="1000" i="1" dirty="0"/>
                    <a:t>MRPL3 </a:t>
                  </a:r>
                  <a:r>
                    <a:rPr lang="en-US" sz="1000" dirty="0"/>
                    <a:t>expression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3310549" y="975419"/>
                  <a:ext cx="143637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i="1" dirty="0"/>
                    <a:t>GFP </a:t>
                  </a:r>
                  <a:r>
                    <a:rPr lang="en-US" sz="1000" dirty="0"/>
                    <a:t>expression</a:t>
                  </a:r>
                </a:p>
              </p:txBody>
            </p:sp>
          </p:grpSp>
          <p:grpSp>
            <p:nvGrpSpPr>
              <p:cNvPr id="41" name="Group 40"/>
              <p:cNvGrpSpPr/>
              <p:nvPr/>
            </p:nvGrpSpPr>
            <p:grpSpPr>
              <a:xfrm>
                <a:off x="550696" y="1919492"/>
                <a:ext cx="415127" cy="352295"/>
                <a:chOff x="979170" y="2550031"/>
                <a:chExt cx="710725" cy="589409"/>
              </a:xfrm>
            </p:grpSpPr>
            <p:sp>
              <p:nvSpPr>
                <p:cNvPr id="42" name="フリーフォーム 19">
                  <a:extLst>
                    <a:ext uri="{FF2B5EF4-FFF2-40B4-BE49-F238E27FC236}">
                      <a16:creationId xmlns:a16="http://schemas.microsoft.com/office/drawing/2014/main" id="{75EE5E4C-92A7-7E45-ABEE-843411717F4C}"/>
                    </a:ext>
                  </a:extLst>
                </p:cNvPr>
                <p:cNvSpPr/>
                <p:nvPr/>
              </p:nvSpPr>
              <p:spPr>
                <a:xfrm>
                  <a:off x="979170" y="2904776"/>
                  <a:ext cx="461010" cy="234664"/>
                </a:xfrm>
                <a:custGeom>
                  <a:avLst/>
                  <a:gdLst>
                    <a:gd name="connsiteX0" fmla="*/ 0 w 641384"/>
                    <a:gd name="connsiteY0" fmla="*/ 346388 h 346388"/>
                    <a:gd name="connsiteX1" fmla="*/ 0 w 641384"/>
                    <a:gd name="connsiteY1" fmla="*/ 0 h 346388"/>
                    <a:gd name="connsiteX2" fmla="*/ 641384 w 641384"/>
                    <a:gd name="connsiteY2" fmla="*/ 0 h 346388"/>
                    <a:gd name="connsiteX3" fmla="*/ 641384 w 641384"/>
                    <a:gd name="connsiteY3" fmla="*/ 346388 h 3463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41384" h="346388">
                      <a:moveTo>
                        <a:pt x="0" y="346388"/>
                      </a:moveTo>
                      <a:lnTo>
                        <a:pt x="0" y="0"/>
                      </a:lnTo>
                      <a:lnTo>
                        <a:pt x="641384" y="0"/>
                      </a:lnTo>
                      <a:lnTo>
                        <a:pt x="641384" y="346388"/>
                      </a:lnTo>
                    </a:path>
                  </a:pathLst>
                </a:cu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984070" y="2550031"/>
                  <a:ext cx="705825" cy="3861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ns</a:t>
                  </a:r>
                </a:p>
              </p:txBody>
            </p:sp>
          </p:grpSp>
        </p:grpSp>
        <p:grpSp>
          <p:nvGrpSpPr>
            <p:cNvPr id="44" name="Group 43"/>
            <p:cNvGrpSpPr/>
            <p:nvPr/>
          </p:nvGrpSpPr>
          <p:grpSpPr>
            <a:xfrm>
              <a:off x="2014858" y="1869004"/>
              <a:ext cx="415127" cy="352295"/>
              <a:chOff x="979170" y="2550031"/>
              <a:chExt cx="710725" cy="589409"/>
            </a:xfrm>
          </p:grpSpPr>
          <p:sp>
            <p:nvSpPr>
              <p:cNvPr id="45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3" name="Group 72"/>
          <p:cNvGrpSpPr/>
          <p:nvPr/>
        </p:nvGrpSpPr>
        <p:grpSpPr>
          <a:xfrm>
            <a:off x="3043034" y="789654"/>
            <a:ext cx="3563249" cy="2297730"/>
            <a:chOff x="3032760" y="846161"/>
            <a:chExt cx="3444239" cy="2198028"/>
          </a:xfrm>
        </p:grpSpPr>
        <p:grpSp>
          <p:nvGrpSpPr>
            <p:cNvPr id="66" name="Group 65"/>
            <p:cNvGrpSpPr/>
            <p:nvPr/>
          </p:nvGrpSpPr>
          <p:grpSpPr>
            <a:xfrm>
              <a:off x="3032760" y="846161"/>
              <a:ext cx="3444239" cy="2198028"/>
              <a:chOff x="3032760" y="846161"/>
              <a:chExt cx="3444239" cy="2198028"/>
            </a:xfrm>
          </p:grpSpPr>
          <p:grpSp>
            <p:nvGrpSpPr>
              <p:cNvPr id="19" name="Group 18"/>
              <p:cNvGrpSpPr/>
              <p:nvPr/>
            </p:nvGrpSpPr>
            <p:grpSpPr>
              <a:xfrm>
                <a:off x="3032760" y="846161"/>
                <a:ext cx="3444239" cy="2198028"/>
                <a:chOff x="1219200" y="3488890"/>
                <a:chExt cx="4522850" cy="2499907"/>
              </a:xfrm>
            </p:grpSpPr>
            <p:pic>
              <p:nvPicPr>
                <p:cNvPr id="5" name="Picture 4"/>
                <p:cNvPicPr/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219200" y="4122420"/>
                  <a:ext cx="2158144" cy="1836418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6" name="Picture 5"/>
                <p:cNvPicPr/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65550" y="3975139"/>
                  <a:ext cx="2476500" cy="2013658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7" name="Rectangle 6"/>
                <p:cNvSpPr/>
                <p:nvPr/>
              </p:nvSpPr>
              <p:spPr>
                <a:xfrm>
                  <a:off x="1569395" y="3488890"/>
                  <a:ext cx="3418613" cy="31504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1200" b="1" dirty="0">
                      <a:latin typeface="Arial" panose="020B0604020202020204" pitchFamily="34" charset="0"/>
                      <a:ea typeface="游明朝" panose="02020400000000000000" pitchFamily="18" charset="-128"/>
                    </a:rPr>
                    <a:t>strains containing </a:t>
                  </a:r>
                  <a:r>
                    <a:rPr lang="en-US" sz="1200" b="1" i="1" dirty="0"/>
                    <a:t>MRPS35</a:t>
                  </a:r>
                  <a:r>
                    <a:rPr lang="en-US" sz="1200" b="1" dirty="0"/>
                    <a:t>pro-</a:t>
                  </a:r>
                  <a:r>
                    <a:rPr lang="en-US" sz="1200" b="1" i="1" dirty="0"/>
                    <a:t>GFP</a:t>
                  </a:r>
                  <a:endParaRPr lang="en-US" sz="1200" dirty="0"/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1480856" y="3809411"/>
                  <a:ext cx="2189277" cy="2800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 </a:t>
                  </a:r>
                  <a:r>
                    <a:rPr lang="en-US" sz="1000" i="1" dirty="0"/>
                    <a:t>MRPS35 </a:t>
                  </a:r>
                  <a:r>
                    <a:rPr lang="en-US" sz="1000" dirty="0"/>
                    <a:t>expression</a:t>
                  </a: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3625794" y="3790737"/>
                  <a:ext cx="1436370" cy="2800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i="1" dirty="0"/>
                    <a:t>GFP </a:t>
                  </a:r>
                  <a:r>
                    <a:rPr lang="en-US" sz="1000" dirty="0"/>
                    <a:t>expression</a:t>
                  </a:r>
                </a:p>
              </p:txBody>
            </p:sp>
          </p:grpSp>
          <p:grpSp>
            <p:nvGrpSpPr>
              <p:cNvPr id="50" name="Group 49"/>
              <p:cNvGrpSpPr/>
              <p:nvPr/>
            </p:nvGrpSpPr>
            <p:grpSpPr>
              <a:xfrm>
                <a:off x="3462190" y="2003640"/>
                <a:ext cx="415127" cy="352295"/>
                <a:chOff x="979170" y="2550031"/>
                <a:chExt cx="710725" cy="589409"/>
              </a:xfrm>
            </p:grpSpPr>
            <p:sp>
              <p:nvSpPr>
                <p:cNvPr id="51" name="フリーフォーム 19">
                  <a:extLst>
                    <a:ext uri="{FF2B5EF4-FFF2-40B4-BE49-F238E27FC236}">
                      <a16:creationId xmlns:a16="http://schemas.microsoft.com/office/drawing/2014/main" id="{75EE5E4C-92A7-7E45-ABEE-843411717F4C}"/>
                    </a:ext>
                  </a:extLst>
                </p:cNvPr>
                <p:cNvSpPr/>
                <p:nvPr/>
              </p:nvSpPr>
              <p:spPr>
                <a:xfrm>
                  <a:off x="979170" y="2904776"/>
                  <a:ext cx="461010" cy="234664"/>
                </a:xfrm>
                <a:custGeom>
                  <a:avLst/>
                  <a:gdLst>
                    <a:gd name="connsiteX0" fmla="*/ 0 w 641384"/>
                    <a:gd name="connsiteY0" fmla="*/ 346388 h 346388"/>
                    <a:gd name="connsiteX1" fmla="*/ 0 w 641384"/>
                    <a:gd name="connsiteY1" fmla="*/ 0 h 346388"/>
                    <a:gd name="connsiteX2" fmla="*/ 641384 w 641384"/>
                    <a:gd name="connsiteY2" fmla="*/ 0 h 346388"/>
                    <a:gd name="connsiteX3" fmla="*/ 641384 w 641384"/>
                    <a:gd name="connsiteY3" fmla="*/ 346388 h 3463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41384" h="346388">
                      <a:moveTo>
                        <a:pt x="0" y="346388"/>
                      </a:moveTo>
                      <a:lnTo>
                        <a:pt x="0" y="0"/>
                      </a:lnTo>
                      <a:lnTo>
                        <a:pt x="641384" y="0"/>
                      </a:lnTo>
                      <a:lnTo>
                        <a:pt x="641384" y="346388"/>
                      </a:lnTo>
                    </a:path>
                  </a:pathLst>
                </a:cu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984070" y="2550031"/>
                  <a:ext cx="705825" cy="3861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ns</a:t>
                  </a:r>
                </a:p>
              </p:txBody>
            </p:sp>
          </p:grpSp>
        </p:grpSp>
        <p:grpSp>
          <p:nvGrpSpPr>
            <p:cNvPr id="53" name="Group 52"/>
            <p:cNvGrpSpPr/>
            <p:nvPr/>
          </p:nvGrpSpPr>
          <p:grpSpPr>
            <a:xfrm>
              <a:off x="4926352" y="1953151"/>
              <a:ext cx="415127" cy="352295"/>
              <a:chOff x="979170" y="2550031"/>
              <a:chExt cx="710725" cy="589409"/>
            </a:xfrm>
          </p:grpSpPr>
          <p:sp>
            <p:nvSpPr>
              <p:cNvPr id="54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4" name="Group 73"/>
          <p:cNvGrpSpPr/>
          <p:nvPr/>
        </p:nvGrpSpPr>
        <p:grpSpPr>
          <a:xfrm>
            <a:off x="3005191" y="3424493"/>
            <a:ext cx="3852809" cy="2108424"/>
            <a:chOff x="3044190" y="3290646"/>
            <a:chExt cx="3813810" cy="2085054"/>
          </a:xfrm>
        </p:grpSpPr>
        <p:sp>
          <p:nvSpPr>
            <p:cNvPr id="25" name="TextBox 24"/>
            <p:cNvSpPr txBox="1"/>
            <p:nvPr/>
          </p:nvSpPr>
          <p:spPr>
            <a:xfrm>
              <a:off x="3403461" y="3556742"/>
              <a:ext cx="1434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/>
                <a:t>AIM33 </a:t>
              </a:r>
              <a:r>
                <a:rPr lang="en-US" sz="1000" dirty="0"/>
                <a:t>expression</a:t>
              </a:r>
            </a:p>
          </p:txBody>
        </p:sp>
        <p:grpSp>
          <p:nvGrpSpPr>
            <p:cNvPr id="70" name="Group 69"/>
            <p:cNvGrpSpPr/>
            <p:nvPr/>
          </p:nvGrpSpPr>
          <p:grpSpPr>
            <a:xfrm>
              <a:off x="3044190" y="3290646"/>
              <a:ext cx="3813810" cy="2085054"/>
              <a:chOff x="3044190" y="3290646"/>
              <a:chExt cx="3813810" cy="2085054"/>
            </a:xfrm>
          </p:grpSpPr>
          <p:grpSp>
            <p:nvGrpSpPr>
              <p:cNvPr id="68" name="Group 67"/>
              <p:cNvGrpSpPr/>
              <p:nvPr/>
            </p:nvGrpSpPr>
            <p:grpSpPr>
              <a:xfrm>
                <a:off x="3044190" y="3290646"/>
                <a:ext cx="3813810" cy="2085054"/>
                <a:chOff x="3044190" y="3279426"/>
                <a:chExt cx="3813810" cy="2085054"/>
              </a:xfrm>
            </p:grpSpPr>
            <p:grpSp>
              <p:nvGrpSpPr>
                <p:cNvPr id="21" name="Group 20"/>
                <p:cNvGrpSpPr/>
                <p:nvPr/>
              </p:nvGrpSpPr>
              <p:grpSpPr>
                <a:xfrm>
                  <a:off x="3044190" y="3279426"/>
                  <a:ext cx="3813810" cy="2085054"/>
                  <a:chOff x="800100" y="2236735"/>
                  <a:chExt cx="5059680" cy="2819135"/>
                </a:xfrm>
              </p:grpSpPr>
              <p:pic>
                <p:nvPicPr>
                  <p:cNvPr id="22" name="Picture 21"/>
                  <p:cNvPicPr/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00100" y="2846632"/>
                    <a:ext cx="2308860" cy="216351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</p:pic>
              <p:pic>
                <p:nvPicPr>
                  <p:cNvPr id="23" name="Picture 22"/>
                  <p:cNvPicPr/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261360" y="2734634"/>
                    <a:ext cx="2598420" cy="2321236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</p:pic>
              <p:sp>
                <p:nvSpPr>
                  <p:cNvPr id="24" name="Rectangle 23"/>
                  <p:cNvSpPr/>
                  <p:nvPr/>
                </p:nvSpPr>
                <p:spPr>
                  <a:xfrm>
                    <a:off x="1293772" y="2236735"/>
                    <a:ext cx="3313424" cy="374522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ja-JP" sz="1200" b="1" dirty="0">
                        <a:latin typeface="Arial" panose="020B0604020202020204" pitchFamily="34" charset="0"/>
                        <a:ea typeface="游明朝" panose="02020400000000000000" pitchFamily="18" charset="-128"/>
                      </a:rPr>
                      <a:t>strains containing </a:t>
                    </a:r>
                    <a:r>
                      <a:rPr lang="en-US" sz="1200" b="1" i="1" dirty="0"/>
                      <a:t>AIM33</a:t>
                    </a:r>
                    <a:r>
                      <a:rPr lang="en-US" sz="1200" b="1" dirty="0"/>
                      <a:t>pro-</a:t>
                    </a:r>
                    <a:r>
                      <a:rPr lang="en-US" sz="1200" b="1" i="1" dirty="0"/>
                      <a:t>GFP</a:t>
                    </a:r>
                    <a:endParaRPr lang="en-US" sz="1200" dirty="0"/>
                  </a:p>
                </p:txBody>
              </p:sp>
            </p:grpSp>
            <p:grpSp>
              <p:nvGrpSpPr>
                <p:cNvPr id="47" name="Group 46"/>
                <p:cNvGrpSpPr/>
                <p:nvPr/>
              </p:nvGrpSpPr>
              <p:grpSpPr>
                <a:xfrm>
                  <a:off x="3495849" y="4449520"/>
                  <a:ext cx="415127" cy="352295"/>
                  <a:chOff x="979170" y="2550031"/>
                  <a:chExt cx="710725" cy="589409"/>
                </a:xfrm>
              </p:grpSpPr>
              <p:sp>
                <p:nvSpPr>
                  <p:cNvPr id="48" name="フリーフォーム 19">
                    <a:extLst>
                      <a:ext uri="{FF2B5EF4-FFF2-40B4-BE49-F238E27FC236}">
                        <a16:creationId xmlns:a16="http://schemas.microsoft.com/office/drawing/2014/main" id="{75EE5E4C-92A7-7E45-ABEE-843411717F4C}"/>
                      </a:ext>
                    </a:extLst>
                  </p:cNvPr>
                  <p:cNvSpPr/>
                  <p:nvPr/>
                </p:nvSpPr>
                <p:spPr>
                  <a:xfrm>
                    <a:off x="979170" y="2904776"/>
                    <a:ext cx="461010" cy="234664"/>
                  </a:xfrm>
                  <a:custGeom>
                    <a:avLst/>
                    <a:gdLst>
                      <a:gd name="connsiteX0" fmla="*/ 0 w 641384"/>
                      <a:gd name="connsiteY0" fmla="*/ 346388 h 346388"/>
                      <a:gd name="connsiteX1" fmla="*/ 0 w 641384"/>
                      <a:gd name="connsiteY1" fmla="*/ 0 h 346388"/>
                      <a:gd name="connsiteX2" fmla="*/ 641384 w 641384"/>
                      <a:gd name="connsiteY2" fmla="*/ 0 h 346388"/>
                      <a:gd name="connsiteX3" fmla="*/ 641384 w 641384"/>
                      <a:gd name="connsiteY3" fmla="*/ 346388 h 34638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641384" h="346388">
                        <a:moveTo>
                          <a:pt x="0" y="346388"/>
                        </a:moveTo>
                        <a:lnTo>
                          <a:pt x="0" y="0"/>
                        </a:lnTo>
                        <a:lnTo>
                          <a:pt x="641384" y="0"/>
                        </a:lnTo>
                        <a:lnTo>
                          <a:pt x="641384" y="346388"/>
                        </a:lnTo>
                      </a:path>
                    </a:pathLst>
                  </a:custGeom>
                  <a:ln w="1270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984070" y="2550031"/>
                    <a:ext cx="705825" cy="3861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/>
                      <a:t>ns</a:t>
                    </a:r>
                  </a:p>
                </p:txBody>
              </p:sp>
            </p:grpSp>
          </p:grpSp>
          <p:sp>
            <p:nvSpPr>
              <p:cNvPr id="26" name="TextBox 25"/>
              <p:cNvSpPr txBox="1"/>
              <p:nvPr/>
            </p:nvSpPr>
            <p:spPr>
              <a:xfrm>
                <a:off x="5161236" y="3581842"/>
                <a:ext cx="11161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i="1" dirty="0"/>
                  <a:t>GFP </a:t>
                </a:r>
                <a:r>
                  <a:rPr lang="en-US" sz="1000" dirty="0"/>
                  <a:t>expression</a:t>
                </a:r>
              </a:p>
            </p:txBody>
          </p:sp>
        </p:grpSp>
        <p:grpSp>
          <p:nvGrpSpPr>
            <p:cNvPr id="56" name="Group 55"/>
            <p:cNvGrpSpPr/>
            <p:nvPr/>
          </p:nvGrpSpPr>
          <p:grpSpPr>
            <a:xfrm>
              <a:off x="5285380" y="4359762"/>
              <a:ext cx="415127" cy="352295"/>
              <a:chOff x="979170" y="2550031"/>
              <a:chExt cx="710725" cy="589409"/>
            </a:xfrm>
          </p:grpSpPr>
          <p:sp>
            <p:nvSpPr>
              <p:cNvPr id="57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</p:grpSp>
      <p:grpSp>
        <p:nvGrpSpPr>
          <p:cNvPr id="75" name="Group 74"/>
          <p:cNvGrpSpPr/>
          <p:nvPr/>
        </p:nvGrpSpPr>
        <p:grpSpPr>
          <a:xfrm>
            <a:off x="0" y="6137763"/>
            <a:ext cx="4118610" cy="2392509"/>
            <a:chOff x="1299210" y="5703741"/>
            <a:chExt cx="4118610" cy="2392509"/>
          </a:xfrm>
        </p:grpSpPr>
        <p:grpSp>
          <p:nvGrpSpPr>
            <p:cNvPr id="27" name="Group 26"/>
            <p:cNvGrpSpPr/>
            <p:nvPr/>
          </p:nvGrpSpPr>
          <p:grpSpPr>
            <a:xfrm>
              <a:off x="1299210" y="5703741"/>
              <a:ext cx="4118610" cy="2392509"/>
              <a:chOff x="857250" y="5257684"/>
              <a:chExt cx="4674870" cy="2625206"/>
            </a:xfrm>
          </p:grpSpPr>
          <p:pic>
            <p:nvPicPr>
              <p:cNvPr id="28" name="Picture 27"/>
              <p:cNvPicPr/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57250" y="5709284"/>
                <a:ext cx="2164080" cy="217360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9" name="Picture 28"/>
              <p:cNvPicPr/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90078" y="5766434"/>
                <a:ext cx="2342042" cy="2116455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0" name="Rectangle 29"/>
              <p:cNvSpPr/>
              <p:nvPr/>
            </p:nvSpPr>
            <p:spPr>
              <a:xfrm>
                <a:off x="1452638" y="5257684"/>
                <a:ext cx="2778457" cy="30394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1200" b="1" dirty="0">
                    <a:latin typeface="Arial" panose="020B0604020202020204" pitchFamily="34" charset="0"/>
                    <a:ea typeface="游明朝" panose="02020400000000000000" pitchFamily="18" charset="-128"/>
                  </a:rPr>
                  <a:t>strains containing </a:t>
                </a:r>
                <a:r>
                  <a:rPr lang="en-US" sz="1200" b="1" i="1" dirty="0"/>
                  <a:t>IBA57</a:t>
                </a:r>
                <a:r>
                  <a:rPr lang="en-US" sz="1200" b="1" dirty="0"/>
                  <a:t>pro-</a:t>
                </a:r>
                <a:r>
                  <a:rPr lang="en-US" sz="1200" b="1" i="1" dirty="0"/>
                  <a:t>GFP</a:t>
                </a:r>
                <a:endParaRPr lang="en-US" sz="1200" dirty="0"/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1605141" y="5972282"/>
              <a:ext cx="14347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/>
                <a:t>IBA57 </a:t>
              </a:r>
              <a:r>
                <a:rPr lang="en-US" sz="1000" dirty="0"/>
                <a:t>expression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552089" y="5956838"/>
              <a:ext cx="11161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/>
                <a:t>GFP </a:t>
              </a:r>
              <a:r>
                <a:rPr lang="en-US" sz="1000" dirty="0"/>
                <a:t>expression</a:t>
              </a:r>
            </a:p>
          </p:txBody>
        </p:sp>
        <p:grpSp>
          <p:nvGrpSpPr>
            <p:cNvPr id="59" name="Group 58"/>
            <p:cNvGrpSpPr/>
            <p:nvPr/>
          </p:nvGrpSpPr>
          <p:grpSpPr>
            <a:xfrm>
              <a:off x="1846563" y="7069303"/>
              <a:ext cx="415127" cy="352295"/>
              <a:chOff x="979170" y="2550031"/>
              <a:chExt cx="710725" cy="589409"/>
            </a:xfrm>
          </p:grpSpPr>
          <p:sp>
            <p:nvSpPr>
              <p:cNvPr id="60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ns</a:t>
                </a:r>
              </a:p>
            </p:txBody>
          </p:sp>
        </p:grpSp>
        <p:grpSp>
          <p:nvGrpSpPr>
            <p:cNvPr id="62" name="Group 61"/>
            <p:cNvGrpSpPr/>
            <p:nvPr/>
          </p:nvGrpSpPr>
          <p:grpSpPr>
            <a:xfrm>
              <a:off x="3737071" y="6771983"/>
              <a:ext cx="415127" cy="352295"/>
              <a:chOff x="979170" y="2550031"/>
              <a:chExt cx="710725" cy="589409"/>
            </a:xfrm>
          </p:grpSpPr>
          <p:sp>
            <p:nvSpPr>
              <p:cNvPr id="63" name="フリーフォーム 19">
                <a:extLst>
                  <a:ext uri="{FF2B5EF4-FFF2-40B4-BE49-F238E27FC236}">
                    <a16:creationId xmlns:a16="http://schemas.microsoft.com/office/drawing/2014/main" id="{75EE5E4C-92A7-7E45-ABEE-843411717F4C}"/>
                  </a:ext>
                </a:extLst>
              </p:cNvPr>
              <p:cNvSpPr/>
              <p:nvPr/>
            </p:nvSpPr>
            <p:spPr>
              <a:xfrm>
                <a:off x="979170" y="2904776"/>
                <a:ext cx="461010" cy="234664"/>
              </a:xfrm>
              <a:custGeom>
                <a:avLst/>
                <a:gdLst>
                  <a:gd name="connsiteX0" fmla="*/ 0 w 641384"/>
                  <a:gd name="connsiteY0" fmla="*/ 346388 h 346388"/>
                  <a:gd name="connsiteX1" fmla="*/ 0 w 641384"/>
                  <a:gd name="connsiteY1" fmla="*/ 0 h 346388"/>
                  <a:gd name="connsiteX2" fmla="*/ 641384 w 641384"/>
                  <a:gd name="connsiteY2" fmla="*/ 0 h 346388"/>
                  <a:gd name="connsiteX3" fmla="*/ 641384 w 641384"/>
                  <a:gd name="connsiteY3" fmla="*/ 346388 h 346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41384" h="346388">
                    <a:moveTo>
                      <a:pt x="0" y="346388"/>
                    </a:moveTo>
                    <a:lnTo>
                      <a:pt x="0" y="0"/>
                    </a:lnTo>
                    <a:lnTo>
                      <a:pt x="641384" y="0"/>
                    </a:lnTo>
                    <a:lnTo>
                      <a:pt x="641384" y="346388"/>
                    </a:lnTo>
                  </a:path>
                </a:pathLst>
              </a:custGeom>
              <a:ln w="1270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984070" y="2550031"/>
                <a:ext cx="705825" cy="3861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**</a:t>
                </a:r>
              </a:p>
            </p:txBody>
          </p:sp>
        </p:grpSp>
      </p:grpSp>
      <p:sp>
        <p:nvSpPr>
          <p:cNvPr id="76" name="TextBox 75"/>
          <p:cNvSpPr txBox="1"/>
          <p:nvPr/>
        </p:nvSpPr>
        <p:spPr>
          <a:xfrm>
            <a:off x="4685" y="330674"/>
            <a:ext cx="4161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2925167" y="308063"/>
            <a:ext cx="3287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3036511" y="2902799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6032" y="2929537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5443" y="5581604"/>
            <a:ext cx="339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78</TotalTime>
  <Words>60</Words>
  <Application>Microsoft Office PowerPoint</Application>
  <PresentationFormat>On-screen Show (4:3)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テーマ</vt:lpstr>
      <vt:lpstr>PowerPoint Presentation</vt:lpstr>
    </vt:vector>
  </TitlesOfParts>
  <Company>筑波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Arvin Valderrama</dc:creator>
  <cp:lastModifiedBy>chn off32</cp:lastModifiedBy>
  <cp:revision>1030</cp:revision>
  <cp:lastPrinted>2012-10-01T23:38:13Z</cp:lastPrinted>
  <dcterms:created xsi:type="dcterms:W3CDTF">2014-04-21T15:29:02Z</dcterms:created>
  <dcterms:modified xsi:type="dcterms:W3CDTF">2021-05-03T03:00:42Z</dcterms:modified>
</cp:coreProperties>
</file>